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notesSlides/notesSlide1.xml" ContentType="application/vnd.openxmlformats-officedocument.presentationml.notesSlide+xml"/>
  <Override PartName="/ppt/tags/tag6.xml" ContentType="application/vnd.openxmlformats-officedocument.presentationml.tags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5"/>
  </p:notesMasterIdLst>
  <p:sldIdLst>
    <p:sldId id="267" r:id="rId2"/>
    <p:sldId id="268" r:id="rId3"/>
    <p:sldId id="269" r:id="rId4"/>
  </p:sldIdLst>
  <p:sldSz cx="7772400" cy="10058400"/>
  <p:notesSz cx="6858000" cy="9144000"/>
  <p:embeddedFontLst>
    <p:embeddedFont>
      <p:font typeface="Calibri" panose="020F0502020204030204" pitchFamily="34" charset="0"/>
      <p:regular r:id="rId6"/>
      <p:bold r:id="rId7"/>
      <p:italic r:id="rId8"/>
      <p:boldItalic r:id="rId9"/>
    </p:embeddedFont>
  </p:embeddedFontLst>
  <p:custDataLst>
    <p:tags r:id="rId10"/>
  </p:custData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 panose="020B0604020202020204"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 panose="020B0604020202020204"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 panose="020B0604020202020204"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 panose="020B0604020202020204"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 panose="020B0604020202020204"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 panose="020B0604020202020204"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 panose="020B0604020202020204"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 panose="020B0604020202020204"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 panose="020B0604020202020204"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9pPr>
  </p:defaultTextStyle>
  <p:extLst>
    <p:ext uri="{EFAFB233-063F-42B5-8137-9DF3F51BA10A}">
      <p15:sldGuideLst xmlns:p15="http://schemas.microsoft.com/office/powerpoint/2012/main">
        <p15:guide id="1" orient="horz" pos="3193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3" d="100"/>
          <a:sy n="73" d="100"/>
        </p:scale>
        <p:origin x="1530" y="36"/>
      </p:cViewPr>
      <p:guideLst>
        <p:guide orient="horz" pos="3193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3.fntdata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font" Target="fonts/font2.fntdata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1.fntdata"/><Relationship Id="rId11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openxmlformats.org/officeDocument/2006/relationships/tags" Target="tags/tag1.xml"/><Relationship Id="rId4" Type="http://schemas.openxmlformats.org/officeDocument/2006/relationships/slide" Target="slides/slide3.xml"/><Relationship Id="rId9" Type="http://schemas.openxmlformats.org/officeDocument/2006/relationships/font" Target="fonts/font4.fntdata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2104480" y="685800"/>
            <a:ext cx="26496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 panose="020B0604020202020204"/>
              <a:buChar char="●"/>
              <a:defRPr sz="1100" b="0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 panose="020B0604020202020204"/>
              <a:buChar char="○"/>
              <a:defRPr sz="1100" b="0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 panose="020B0604020202020204"/>
              <a:buChar char="■"/>
              <a:defRPr sz="1100" b="0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 panose="020B0604020202020204"/>
              <a:buChar char="●"/>
              <a:defRPr sz="1100" b="0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 panose="020B0604020202020204"/>
              <a:buChar char="○"/>
              <a:defRPr sz="1100" b="0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 panose="020B0604020202020204"/>
              <a:buChar char="■"/>
              <a:defRPr sz="1100" b="0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 panose="020B0604020202020204"/>
              <a:buChar char="●"/>
              <a:defRPr sz="1100" b="0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 panose="020B0604020202020204"/>
              <a:buChar char="○"/>
              <a:defRPr sz="1100" b="0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 panose="020B0604020202020204"/>
              <a:buChar char="■"/>
              <a:defRPr sz="1100" b="0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 panose="020B0604020202020204"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 panose="020B0604020202020204"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 panose="020B0604020202020204"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 panose="020B0604020202020204"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 panose="020B0604020202020204"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 panose="020B0604020202020204"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 panose="020B0604020202020204"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 panose="020B0604020202020204"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 panose="020B0604020202020204"/>
      <a:defRPr sz="1400" b="0" i="0" u="none" strike="noStrike" cap="none">
        <a:solidFill>
          <a:srgbClr val="000000"/>
        </a:solidFill>
        <a:latin typeface="Arial" panose="020B0604020202020204"/>
        <a:ea typeface="Arial" panose="020B0604020202020204"/>
        <a:cs typeface="Arial" panose="020B0604020202020204"/>
        <a:sym typeface="Arial" panose="020B0604020202020204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04480" y="685800"/>
            <a:ext cx="26496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52" name="Google Shape;52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04480" y="685800"/>
            <a:ext cx="26496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52" name="Google Shape;52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3"/>
          <p:cNvSpPr txBox="1">
            <a:spLocks noGrp="1"/>
          </p:cNvSpPr>
          <p:nvPr>
            <p:ph type="ctrTitle"/>
          </p:nvPr>
        </p:nvSpPr>
        <p:spPr>
          <a:xfrm>
            <a:off x="264952" y="1456058"/>
            <a:ext cx="7242600" cy="401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13"/>
          <p:cNvSpPr txBox="1">
            <a:spLocks noGrp="1"/>
          </p:cNvSpPr>
          <p:nvPr>
            <p:ph type="subTitle" idx="1"/>
          </p:nvPr>
        </p:nvSpPr>
        <p:spPr>
          <a:xfrm>
            <a:off x="264945" y="5542289"/>
            <a:ext cx="7242600" cy="1550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13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Google Shape;47;p22"/>
          <p:cNvSpPr txBox="1">
            <a:spLocks noGrp="1"/>
          </p:cNvSpPr>
          <p:nvPr>
            <p:ph type="title" hasCustomPrompt="1"/>
          </p:nvPr>
        </p:nvSpPr>
        <p:spPr>
          <a:xfrm>
            <a:off x="264945" y="2163089"/>
            <a:ext cx="7242600" cy="3839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8" name="Google Shape;48;p22"/>
          <p:cNvSpPr txBox="1">
            <a:spLocks noGrp="1"/>
          </p:cNvSpPr>
          <p:nvPr>
            <p:ph type="body" idx="1"/>
          </p:nvPr>
        </p:nvSpPr>
        <p:spPr>
          <a:xfrm>
            <a:off x="264945" y="6164351"/>
            <a:ext cx="7242600" cy="2543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9" name="Google Shape;49;p22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14"/>
          <p:cNvSpPr txBox="1">
            <a:spLocks noGrp="1"/>
          </p:cNvSpPr>
          <p:nvPr>
            <p:ph type="title"/>
          </p:nvPr>
        </p:nvSpPr>
        <p:spPr>
          <a:xfrm>
            <a:off x="264945" y="4206107"/>
            <a:ext cx="7242600" cy="1646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7" name="Google Shape;17;p14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Google Shape;19;p15"/>
          <p:cNvSpPr txBox="1">
            <a:spLocks noGrp="1"/>
          </p:cNvSpPr>
          <p:nvPr>
            <p:ph type="title"/>
          </p:nvPr>
        </p:nvSpPr>
        <p:spPr>
          <a:xfrm>
            <a:off x="264945" y="870271"/>
            <a:ext cx="7242600" cy="1119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15"/>
          <p:cNvSpPr txBox="1">
            <a:spLocks noGrp="1"/>
          </p:cNvSpPr>
          <p:nvPr>
            <p:ph type="body" idx="1"/>
          </p:nvPr>
        </p:nvSpPr>
        <p:spPr>
          <a:xfrm>
            <a:off x="264945" y="2253729"/>
            <a:ext cx="7242600" cy="668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21" name="Google Shape;21;p15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Google Shape;23;p16"/>
          <p:cNvSpPr txBox="1">
            <a:spLocks noGrp="1"/>
          </p:cNvSpPr>
          <p:nvPr>
            <p:ph type="title"/>
          </p:nvPr>
        </p:nvSpPr>
        <p:spPr>
          <a:xfrm>
            <a:off x="264945" y="870271"/>
            <a:ext cx="7242600" cy="1119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16"/>
          <p:cNvSpPr txBox="1">
            <a:spLocks noGrp="1"/>
          </p:cNvSpPr>
          <p:nvPr>
            <p:ph type="body" idx="1"/>
          </p:nvPr>
        </p:nvSpPr>
        <p:spPr>
          <a:xfrm>
            <a:off x="264945" y="2253729"/>
            <a:ext cx="3399900" cy="668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5" name="Google Shape;25;p16"/>
          <p:cNvSpPr txBox="1">
            <a:spLocks noGrp="1"/>
          </p:cNvSpPr>
          <p:nvPr>
            <p:ph type="body" idx="2"/>
          </p:nvPr>
        </p:nvSpPr>
        <p:spPr>
          <a:xfrm>
            <a:off x="4107540" y="2253729"/>
            <a:ext cx="3399900" cy="668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6" name="Google Shape;26;p16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7"/>
          <p:cNvSpPr txBox="1">
            <a:spLocks noGrp="1"/>
          </p:cNvSpPr>
          <p:nvPr>
            <p:ph type="title"/>
          </p:nvPr>
        </p:nvSpPr>
        <p:spPr>
          <a:xfrm>
            <a:off x="264945" y="870271"/>
            <a:ext cx="7242600" cy="1119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7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Google Shape;31;p18"/>
          <p:cNvSpPr txBox="1">
            <a:spLocks noGrp="1"/>
          </p:cNvSpPr>
          <p:nvPr>
            <p:ph type="title"/>
          </p:nvPr>
        </p:nvSpPr>
        <p:spPr>
          <a:xfrm>
            <a:off x="264945" y="1086507"/>
            <a:ext cx="2386800" cy="1477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2" name="Google Shape;32;p18"/>
          <p:cNvSpPr txBox="1">
            <a:spLocks noGrp="1"/>
          </p:cNvSpPr>
          <p:nvPr>
            <p:ph type="body" idx="1"/>
          </p:nvPr>
        </p:nvSpPr>
        <p:spPr>
          <a:xfrm>
            <a:off x="264945" y="2717440"/>
            <a:ext cx="2386800" cy="6217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3" name="Google Shape;33;p18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Google Shape;35;p19"/>
          <p:cNvSpPr txBox="1">
            <a:spLocks noGrp="1"/>
          </p:cNvSpPr>
          <p:nvPr>
            <p:ph type="title"/>
          </p:nvPr>
        </p:nvSpPr>
        <p:spPr>
          <a:xfrm>
            <a:off x="416713" y="880293"/>
            <a:ext cx="5412600" cy="7999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6" name="Google Shape;36;p19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20"/>
          <p:cNvSpPr/>
          <p:nvPr/>
        </p:nvSpPr>
        <p:spPr>
          <a:xfrm>
            <a:off x="3886200" y="-244"/>
            <a:ext cx="3886200" cy="100584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panose="020B0604020202020204"/>
              <a:buNone/>
            </a:pPr>
            <a:endParaRPr sz="1400" b="0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sp>
        <p:nvSpPr>
          <p:cNvPr id="39" name="Google Shape;39;p20"/>
          <p:cNvSpPr txBox="1">
            <a:spLocks noGrp="1"/>
          </p:cNvSpPr>
          <p:nvPr>
            <p:ph type="title"/>
          </p:nvPr>
        </p:nvSpPr>
        <p:spPr>
          <a:xfrm>
            <a:off x="225675" y="2411542"/>
            <a:ext cx="3438300" cy="289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40" name="Google Shape;40;p20"/>
          <p:cNvSpPr txBox="1">
            <a:spLocks noGrp="1"/>
          </p:cNvSpPr>
          <p:nvPr>
            <p:ph type="subTitle" idx="1"/>
          </p:nvPr>
        </p:nvSpPr>
        <p:spPr>
          <a:xfrm>
            <a:off x="225675" y="5481569"/>
            <a:ext cx="3438300" cy="2415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41" name="Google Shape;41;p20"/>
          <p:cNvSpPr txBox="1">
            <a:spLocks noGrp="1"/>
          </p:cNvSpPr>
          <p:nvPr>
            <p:ph type="body" idx="2"/>
          </p:nvPr>
        </p:nvSpPr>
        <p:spPr>
          <a:xfrm>
            <a:off x="4198575" y="1415969"/>
            <a:ext cx="3261600" cy="7226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2" name="Google Shape;42;p20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Google Shape;44;p21"/>
          <p:cNvSpPr txBox="1">
            <a:spLocks noGrp="1"/>
          </p:cNvSpPr>
          <p:nvPr>
            <p:ph type="body" idx="1"/>
          </p:nvPr>
        </p:nvSpPr>
        <p:spPr>
          <a:xfrm>
            <a:off x="264945" y="8273124"/>
            <a:ext cx="5099100" cy="1183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5" name="Google Shape;45;p21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2"/>
          <p:cNvSpPr txBox="1">
            <a:spLocks noGrp="1"/>
          </p:cNvSpPr>
          <p:nvPr>
            <p:ph type="title"/>
          </p:nvPr>
        </p:nvSpPr>
        <p:spPr>
          <a:xfrm>
            <a:off x="264945" y="870271"/>
            <a:ext cx="7242600" cy="1119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 panose="020B0604020202020204"/>
              <a:buNone/>
              <a:defRPr sz="2800" b="0" i="0" u="none" strike="noStrike" cap="none">
                <a:solidFill>
                  <a:schemeClr val="dk1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 panose="020B0604020202020204"/>
              <a:buNone/>
              <a:defRPr sz="2800" b="0" i="0" u="none" strike="noStrike" cap="none">
                <a:solidFill>
                  <a:schemeClr val="dk1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 panose="020B0604020202020204"/>
              <a:buNone/>
              <a:defRPr sz="2800" b="0" i="0" u="none" strike="noStrike" cap="none">
                <a:solidFill>
                  <a:schemeClr val="dk1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 panose="020B0604020202020204"/>
              <a:buNone/>
              <a:defRPr sz="2800" b="0" i="0" u="none" strike="noStrike" cap="none">
                <a:solidFill>
                  <a:schemeClr val="dk1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 panose="020B0604020202020204"/>
              <a:buNone/>
              <a:defRPr sz="2800" b="0" i="0" u="none" strike="noStrike" cap="none">
                <a:solidFill>
                  <a:schemeClr val="dk1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 panose="020B0604020202020204"/>
              <a:buNone/>
              <a:defRPr sz="2800" b="0" i="0" u="none" strike="noStrike" cap="none">
                <a:solidFill>
                  <a:schemeClr val="dk1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 panose="020B0604020202020204"/>
              <a:buNone/>
              <a:defRPr sz="2800" b="0" i="0" u="none" strike="noStrike" cap="none">
                <a:solidFill>
                  <a:schemeClr val="dk1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 panose="020B0604020202020204"/>
              <a:buNone/>
              <a:defRPr sz="2800" b="0" i="0" u="none" strike="noStrike" cap="none">
                <a:solidFill>
                  <a:schemeClr val="dk1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 panose="020B0604020202020204"/>
              <a:buNone/>
              <a:defRPr sz="2800" b="0" i="0" u="none" strike="noStrike" cap="none">
                <a:solidFill>
                  <a:schemeClr val="dk1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9pPr>
          </a:lstStyle>
          <a:p>
            <a:endParaRPr/>
          </a:p>
        </p:txBody>
      </p:sp>
      <p:sp>
        <p:nvSpPr>
          <p:cNvPr id="7" name="Google Shape;7;p12"/>
          <p:cNvSpPr txBox="1">
            <a:spLocks noGrp="1"/>
          </p:cNvSpPr>
          <p:nvPr>
            <p:ph type="body" idx="1"/>
          </p:nvPr>
        </p:nvSpPr>
        <p:spPr>
          <a:xfrm>
            <a:off x="264945" y="2253729"/>
            <a:ext cx="7242600" cy="668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marR="0" lvl="0" indent="-3429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Font typeface="Arial" panose="020B0604020202020204"/>
              <a:buChar char="●"/>
              <a:defRPr sz="18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1pPr>
            <a:lvl2pPr marL="914400" marR="0" lvl="1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 panose="020B0604020202020204"/>
              <a:buChar char="○"/>
              <a:defRPr sz="14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2pPr>
            <a:lvl3pPr marL="1371600" marR="0" lvl="2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 panose="020B0604020202020204"/>
              <a:buChar char="■"/>
              <a:defRPr sz="14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3pPr>
            <a:lvl4pPr marL="1828800" marR="0" lvl="3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 panose="020B0604020202020204"/>
              <a:buChar char="●"/>
              <a:defRPr sz="14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4pPr>
            <a:lvl5pPr marL="2286000" marR="0" lvl="4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 panose="020B0604020202020204"/>
              <a:buChar char="○"/>
              <a:defRPr sz="14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5pPr>
            <a:lvl6pPr marL="2743200" marR="0" lvl="5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 panose="020B0604020202020204"/>
              <a:buChar char="■"/>
              <a:defRPr sz="14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6pPr>
            <a:lvl7pPr marL="3200400" marR="0" lvl="6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 panose="020B0604020202020204"/>
              <a:buChar char="●"/>
              <a:defRPr sz="14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7pPr>
            <a:lvl8pPr marL="3657600" marR="0" lvl="7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 panose="020B0604020202020204"/>
              <a:buChar char="○"/>
              <a:defRPr sz="14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8pPr>
            <a:lvl9pPr marL="4114800" marR="0" lvl="8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 panose="020B0604020202020204"/>
              <a:buChar char="■"/>
              <a:defRPr sz="14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9pPr>
          </a:lstStyle>
          <a:p>
            <a:endParaRPr/>
          </a:p>
        </p:txBody>
      </p:sp>
      <p:sp>
        <p:nvSpPr>
          <p:cNvPr id="8" name="Google Shape;8;p12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  <a:defRPr sz="1000" b="0" i="0" u="none" strike="noStrike" cap="none">
                <a:solidFill>
                  <a:schemeClr val="dk2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 lang="en-GB"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 panose="020B0604020202020204"/>
        <a:defRPr sz="1400" b="0" i="0" u="none" strike="noStrike" cap="none">
          <a:solidFill>
            <a:srgbClr val="000000"/>
          </a:solidFill>
          <a:latin typeface="Arial" panose="020B0604020202020204"/>
          <a:ea typeface="Arial" panose="020B0604020202020204"/>
          <a:cs typeface="Arial" panose="020B0604020202020204"/>
          <a:sym typeface="Arial" panose="020B0604020202020204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3" Type="http://schemas.openxmlformats.org/officeDocument/2006/relationships/tags" Target="../tags/tag4.xml"/><Relationship Id="rId7" Type="http://schemas.openxmlformats.org/officeDocument/2006/relationships/image" Target="../media/image1.png"/><Relationship Id="rId2" Type="http://schemas.openxmlformats.org/officeDocument/2006/relationships/tags" Target="../tags/tag3.xml"/><Relationship Id="rId1" Type="http://schemas.openxmlformats.org/officeDocument/2006/relationships/tags" Target="../tags/tag2.xml"/><Relationship Id="rId6" Type="http://schemas.openxmlformats.org/officeDocument/2006/relationships/notesSlide" Target="../notesSlides/notesSlide1.xml"/><Relationship Id="rId5" Type="http://schemas.openxmlformats.org/officeDocument/2006/relationships/slideLayout" Target="../slideLayouts/slideLayout1.xml"/><Relationship Id="rId10" Type="http://schemas.openxmlformats.org/officeDocument/2006/relationships/image" Target="../media/image4.png"/><Relationship Id="rId4" Type="http://schemas.openxmlformats.org/officeDocument/2006/relationships/tags" Target="../tags/tag5.xml"/><Relationship Id="rId9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7" Type="http://schemas.openxmlformats.org/officeDocument/2006/relationships/image" Target="../media/image8.pn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cid:ii_lrbgxprs1" TargetMode="External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"/>
          <p:cNvSpPr txBox="1"/>
          <p:nvPr/>
        </p:nvSpPr>
        <p:spPr>
          <a:xfrm>
            <a:off x="735965" y="0"/>
            <a:ext cx="6300470" cy="4889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000"/>
              <a:buFont typeface="Arial" panose="020B0604020202020204"/>
              <a:buNone/>
            </a:pPr>
            <a:r>
              <a:rPr lang="en-GB" sz="2000" b="1" i="0" u="none" strike="noStrike" cap="none" dirty="0">
                <a:solidFill>
                  <a:srgbClr val="000000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Figure </a:t>
            </a:r>
            <a:r>
              <a:rPr lang="en-US" altLang="en-GB" sz="2000" b="1" i="0" u="none" strike="noStrike" cap="none" dirty="0">
                <a:solidFill>
                  <a:srgbClr val="000000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S</a:t>
            </a:r>
            <a:r>
              <a:rPr lang="en-GB" sz="2000" b="1" i="0" u="none" strike="noStrike" cap="none" dirty="0">
                <a:solidFill>
                  <a:srgbClr val="000000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1: </a:t>
            </a:r>
            <a:r>
              <a:rPr lang="en-GB" sz="2000" b="1" dirty="0"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UMAP</a:t>
            </a:r>
            <a:r>
              <a:rPr lang="en-US" altLang="en-GB" sz="2000" b="1" dirty="0"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of subgroups in Lym1 of the 4 groups</a:t>
            </a:r>
            <a:endParaRPr lang="en-US" altLang="en-GB" sz="2000" b="1" i="0" u="none" strike="noStrike" cap="none" dirty="0">
              <a:solidFill>
                <a:srgbClr val="000000"/>
              </a:solidFill>
              <a:latin typeface="Calibri" panose="020F0502020204030204"/>
              <a:ea typeface="Calibri" panose="020F0502020204030204"/>
              <a:cs typeface="Calibri" panose="020F0502020204030204"/>
              <a:sym typeface="Calibri" panose="020F0502020204030204"/>
            </a:endParaRPr>
          </a:p>
        </p:txBody>
      </p:sp>
      <p:sp>
        <p:nvSpPr>
          <p:cNvPr id="60" name="Google Shape;60;p1"/>
          <p:cNvSpPr txBox="1"/>
          <p:nvPr/>
        </p:nvSpPr>
        <p:spPr>
          <a:xfrm>
            <a:off x="0" y="6056325"/>
            <a:ext cx="7772400" cy="7969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 panose="020B0604020202020204"/>
              <a:buNone/>
            </a:pPr>
            <a:r>
              <a:rPr lang="en-GB" sz="1000" b="1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(A)</a:t>
            </a:r>
            <a:r>
              <a:rPr lang="en-GB" sz="1000" b="1" dirty="0" err="1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Dotplot</a:t>
            </a:r>
            <a:r>
              <a:rPr 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for Cell Type Identification Markers</a:t>
            </a:r>
            <a:r>
              <a:rPr 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+mn-ea"/>
              </a:rPr>
              <a:t> in different clusters.</a:t>
            </a:r>
            <a:r>
              <a:rPr lang="en-GB" sz="1000" b="1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(B)</a:t>
            </a:r>
            <a:r>
              <a:rPr lang="en-GB" sz="1000" b="1" i="0" u="none" strike="noStrike" cap="none" dirty="0" err="1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FeaturePlot</a:t>
            </a:r>
            <a:r>
              <a:rPr lang="en-GB" sz="1000" b="1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Visualization of </a:t>
            </a:r>
            <a:r>
              <a:rPr 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Cell Type Identification Markers</a:t>
            </a:r>
            <a:r>
              <a:rPr lang="en-GB" sz="1000" b="1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(C) </a:t>
            </a:r>
            <a:r>
              <a:rPr 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UMAP</a:t>
            </a:r>
            <a:r>
              <a:rPr lang="en-US" alt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</a:t>
            </a:r>
            <a:r>
              <a:rPr 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Visualization of the Clustering of </a:t>
            </a:r>
            <a:r>
              <a:rPr lang="en-US" alt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subgroups of Lym1</a:t>
            </a:r>
            <a:r>
              <a:rPr 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from All Patient Samples</a:t>
            </a:r>
            <a:r>
              <a:rPr lang="en-US" alt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and </a:t>
            </a:r>
            <a:r>
              <a:rPr 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(</a:t>
            </a:r>
            <a:r>
              <a:rPr lang="en-US" alt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D</a:t>
            </a:r>
            <a:r>
              <a:rPr 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)UMAP Visualization of Cell Population from Individual Samples</a:t>
            </a:r>
            <a:r>
              <a:rPr lang="en-US" alt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.</a:t>
            </a:r>
            <a:r>
              <a:rPr lang="en-GB" sz="1000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Lym1 </a:t>
            </a:r>
            <a:r>
              <a:rPr lang="en-US" altLang="en-GB" sz="1000" dirty="0" err="1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wa</a:t>
            </a:r>
            <a:r>
              <a:rPr lang="en-GB" sz="1000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s </a:t>
            </a:r>
            <a:r>
              <a:rPr lang="en-GB" sz="1000" dirty="0" err="1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seperated</a:t>
            </a:r>
            <a:r>
              <a:rPr lang="en-GB" sz="1000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into 4 subgroups, and based on the </a:t>
            </a:r>
            <a:r>
              <a:rPr lang="en-US" altLang="en-GB" sz="1000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markers which are showed in </a:t>
            </a:r>
            <a:r>
              <a:rPr lang="en-GB" sz="1000" b="1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A</a:t>
            </a:r>
            <a:r>
              <a:rPr lang="en-GB" sz="1000" b="0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&amp; </a:t>
            </a:r>
            <a:r>
              <a:rPr lang="en-GB" sz="1000" b="1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B</a:t>
            </a:r>
            <a:r>
              <a:rPr lang="en-GB" sz="1000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,</a:t>
            </a:r>
            <a:r>
              <a:rPr lang="en-US" altLang="en-GB" sz="1000" b="1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</a:t>
            </a:r>
            <a:r>
              <a:rPr lang="en-GB" sz="1000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The</a:t>
            </a:r>
            <a:r>
              <a:rPr lang="en-US" altLang="en-GB" sz="1000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subgroups </a:t>
            </a:r>
            <a:r>
              <a:rPr lang="en-GB" sz="1000" b="0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were identified</a:t>
            </a:r>
            <a:r>
              <a:rPr lang="en-US" altLang="en-GB" sz="1000" b="0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. There was a </a:t>
            </a:r>
            <a:r>
              <a:rPr lang="en-US" altLang="en-GB" sz="1000" b="0" i="0" u="none" strike="noStrike" cap="none" dirty="0" err="1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signicant</a:t>
            </a:r>
            <a:r>
              <a:rPr lang="en-US" altLang="en-GB" sz="1000" b="0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loss in naive CD4+T in </a:t>
            </a:r>
            <a:r>
              <a:rPr lang="en-GB" sz="1000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advanced decompensated patient</a:t>
            </a:r>
            <a:r>
              <a:rPr lang="en-GB" sz="1000" b="0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.</a:t>
            </a:r>
            <a:endParaRPr sz="1400" b="0" i="0" u="none" strike="noStrike" cap="none" dirty="0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sp>
        <p:nvSpPr>
          <p:cNvPr id="85" name="Google Shape;85;p1"/>
          <p:cNvSpPr txBox="1"/>
          <p:nvPr/>
        </p:nvSpPr>
        <p:spPr>
          <a:xfrm>
            <a:off x="6953250" y="7191375"/>
            <a:ext cx="9144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panose="020B0604020202020204"/>
              <a:buNone/>
            </a:pPr>
            <a:endParaRPr sz="1400" b="0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pic>
        <p:nvPicPr>
          <p:cNvPr id="3" name="图片 2" descr="Rplot0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7"/>
          <a:stretch>
            <a:fillRect/>
          </a:stretch>
        </p:blipFill>
        <p:spPr>
          <a:xfrm>
            <a:off x="368300" y="649605"/>
            <a:ext cx="3237865" cy="231267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3" name="图片 12" descr="Lym1 total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368300" y="3243580"/>
            <a:ext cx="3237865" cy="231267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83" name="Google Shape;83;p1"/>
          <p:cNvSpPr txBox="1"/>
          <p:nvPr/>
        </p:nvSpPr>
        <p:spPr>
          <a:xfrm>
            <a:off x="330200" y="3173420"/>
            <a:ext cx="4287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</a:pPr>
            <a:r>
              <a:rPr lang="en-GB" sz="1000" b="1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rPr>
              <a:t>C</a:t>
            </a:r>
            <a:endParaRPr sz="1000" b="1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sp>
        <p:nvSpPr>
          <p:cNvPr id="87" name="Google Shape;87;p1"/>
          <p:cNvSpPr txBox="1"/>
          <p:nvPr/>
        </p:nvSpPr>
        <p:spPr>
          <a:xfrm>
            <a:off x="330200" y="598790"/>
            <a:ext cx="4287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</a:pPr>
            <a:r>
              <a:rPr lang="en-GB" sz="1000" b="1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rPr>
              <a:t>A</a:t>
            </a:r>
            <a:endParaRPr sz="1000" b="1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pic>
        <p:nvPicPr>
          <p:cNvPr id="12" name="图片 11" descr="Rplot10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9"/>
          <a:stretch>
            <a:fillRect/>
          </a:stretch>
        </p:blipFill>
        <p:spPr>
          <a:xfrm>
            <a:off x="4179570" y="3243580"/>
            <a:ext cx="3237865" cy="231267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" name="Google Shape;83;p1"/>
          <p:cNvSpPr txBox="1"/>
          <p:nvPr>
            <p:custDataLst>
              <p:tags r:id="rId4"/>
            </p:custDataLst>
          </p:nvPr>
        </p:nvSpPr>
        <p:spPr>
          <a:xfrm>
            <a:off x="4135120" y="3173420"/>
            <a:ext cx="428700" cy="3352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</a:pPr>
            <a:r>
              <a:rPr lang="en-US" altLang="en-GB" sz="1000" b="1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rPr>
              <a:t>D</a:t>
            </a:r>
          </a:p>
        </p:txBody>
      </p:sp>
      <p:pic>
        <p:nvPicPr>
          <p:cNvPr id="4" name="图片 3" descr="Rplot1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179570" y="649605"/>
            <a:ext cx="3237865" cy="231267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82" name="Google Shape;82;p1"/>
          <p:cNvSpPr txBox="1"/>
          <p:nvPr/>
        </p:nvSpPr>
        <p:spPr>
          <a:xfrm>
            <a:off x="4128770" y="567040"/>
            <a:ext cx="4287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</a:pPr>
            <a:r>
              <a:rPr lang="en-GB" sz="1000" b="1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rPr>
              <a:t>B</a:t>
            </a:r>
            <a:endParaRPr sz="1000" b="1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"/>
          <p:cNvSpPr txBox="1"/>
          <p:nvPr/>
        </p:nvSpPr>
        <p:spPr>
          <a:xfrm>
            <a:off x="735965" y="0"/>
            <a:ext cx="6300470" cy="4889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000"/>
              <a:buFont typeface="Arial" panose="020B0604020202020204"/>
              <a:buNone/>
            </a:pPr>
            <a:r>
              <a:rPr lang="en-GB" sz="2000" b="1" i="0" u="none" strike="noStrike" cap="none">
                <a:solidFill>
                  <a:srgbClr val="000000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Figure </a:t>
            </a:r>
            <a:r>
              <a:rPr lang="en-US" altLang="en-GB" sz="2000" b="1" i="0" u="none" strike="noStrike" cap="none">
                <a:solidFill>
                  <a:srgbClr val="000000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S2</a:t>
            </a:r>
            <a:r>
              <a:rPr lang="en-GB" sz="2000" b="1" i="0" u="none" strike="noStrike" cap="none">
                <a:solidFill>
                  <a:srgbClr val="000000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: </a:t>
            </a:r>
            <a:r>
              <a:rPr lang="en-GB" sz="2000" b="1"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UMAP</a:t>
            </a:r>
            <a:r>
              <a:rPr lang="en-US" altLang="en-GB" sz="2000" b="1"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of subgroups in Lym2 of the 4 groups</a:t>
            </a:r>
            <a:endParaRPr lang="en-US" altLang="en-GB" sz="2000" b="1" i="0" u="none" strike="noStrike" cap="none">
              <a:solidFill>
                <a:srgbClr val="000000"/>
              </a:solidFill>
              <a:latin typeface="Calibri" panose="020F0502020204030204"/>
              <a:ea typeface="Calibri" panose="020F0502020204030204"/>
              <a:cs typeface="Calibri" panose="020F0502020204030204"/>
              <a:sym typeface="Calibri" panose="020F0502020204030204"/>
            </a:endParaRPr>
          </a:p>
        </p:txBody>
      </p:sp>
      <p:sp>
        <p:nvSpPr>
          <p:cNvPr id="60" name="Google Shape;60;p1"/>
          <p:cNvSpPr txBox="1"/>
          <p:nvPr/>
        </p:nvSpPr>
        <p:spPr>
          <a:xfrm>
            <a:off x="0" y="6056325"/>
            <a:ext cx="7772400" cy="7969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 panose="020B0604020202020204"/>
              <a:buNone/>
            </a:pPr>
            <a:r>
              <a:rPr lang="en-GB" sz="1000" b="1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(A)</a:t>
            </a:r>
            <a:r>
              <a:rPr lang="en-GB" sz="1000" b="1" dirty="0" err="1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Dotplot</a:t>
            </a:r>
            <a:r>
              <a:rPr 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for Cell Type Identification Markers</a:t>
            </a:r>
            <a:r>
              <a:rPr 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+mn-ea"/>
              </a:rPr>
              <a:t> in different clusters</a:t>
            </a:r>
            <a:r>
              <a:rPr lang="en-US" alt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+mn-ea"/>
              </a:rPr>
              <a:t> in Lym2</a:t>
            </a:r>
            <a:r>
              <a:rPr 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+mn-ea"/>
              </a:rPr>
              <a:t>.</a:t>
            </a:r>
            <a:r>
              <a:rPr lang="en-GB" sz="1000" b="1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(B)</a:t>
            </a:r>
            <a:r>
              <a:rPr lang="en-GB" sz="1000" b="1" i="0" u="none" strike="noStrike" cap="none" dirty="0" err="1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FeaturePlot</a:t>
            </a:r>
            <a:r>
              <a:rPr lang="en-GB" sz="1000" b="1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Visualization of </a:t>
            </a:r>
            <a:r>
              <a:rPr 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Cell Type Identification Markers</a:t>
            </a:r>
            <a:r>
              <a:rPr lang="en-GB" sz="1000" b="1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(C) </a:t>
            </a:r>
            <a:r>
              <a:rPr 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UMAP</a:t>
            </a:r>
            <a:r>
              <a:rPr lang="en-US" alt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</a:t>
            </a:r>
            <a:r>
              <a:rPr 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Visualization of the Clustering of </a:t>
            </a:r>
            <a:r>
              <a:rPr lang="en-US" alt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subgroups of Lym2</a:t>
            </a:r>
            <a:r>
              <a:rPr 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from All Patient Samples</a:t>
            </a:r>
            <a:r>
              <a:rPr lang="en-US" alt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and </a:t>
            </a:r>
            <a:r>
              <a:rPr 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(</a:t>
            </a:r>
            <a:r>
              <a:rPr lang="en-US" alt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D</a:t>
            </a:r>
            <a:r>
              <a:rPr 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)UMAP Visualization of Cell Population from Individual Samples</a:t>
            </a:r>
            <a:r>
              <a:rPr lang="en-US" altLang="en-GB" sz="1000" b="1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.</a:t>
            </a:r>
            <a:r>
              <a:rPr lang="en-GB" sz="1000" dirty="0" err="1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Lym</a:t>
            </a:r>
            <a:r>
              <a:rPr lang="en-US" altLang="en-GB" sz="1000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2</a:t>
            </a:r>
            <a:r>
              <a:rPr lang="en-GB" sz="1000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</a:t>
            </a:r>
            <a:r>
              <a:rPr lang="en-US" altLang="en-GB" sz="1000" dirty="0" err="1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wa</a:t>
            </a:r>
            <a:r>
              <a:rPr lang="en-GB" sz="1000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s </a:t>
            </a:r>
            <a:r>
              <a:rPr lang="en-GB" sz="1000" dirty="0" err="1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seperated</a:t>
            </a:r>
            <a:r>
              <a:rPr lang="en-GB" sz="1000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into </a:t>
            </a:r>
            <a:r>
              <a:rPr lang="en-US" altLang="en-GB" sz="1000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3</a:t>
            </a:r>
            <a:r>
              <a:rPr lang="en-GB" sz="1000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subgroups, and based on the </a:t>
            </a:r>
            <a:r>
              <a:rPr lang="en-US" altLang="en-GB" sz="1000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markers which are showed in </a:t>
            </a:r>
            <a:r>
              <a:rPr lang="en-GB" sz="1000" b="1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A</a:t>
            </a:r>
            <a:r>
              <a:rPr lang="en-GB" sz="1000" b="0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&amp; </a:t>
            </a:r>
            <a:r>
              <a:rPr lang="en-GB" sz="1000" b="1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B</a:t>
            </a:r>
            <a:r>
              <a:rPr lang="en-GB" sz="1000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,</a:t>
            </a:r>
            <a:r>
              <a:rPr lang="en-US" altLang="en-GB" sz="1000" b="1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</a:t>
            </a:r>
            <a:r>
              <a:rPr lang="en-GB" sz="1000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The</a:t>
            </a:r>
            <a:r>
              <a:rPr lang="en-US" altLang="en-GB" sz="1000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subgroups </a:t>
            </a:r>
            <a:r>
              <a:rPr lang="en-GB" sz="1000" b="0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were identified</a:t>
            </a:r>
            <a:r>
              <a:rPr lang="en-US" altLang="en-GB" sz="1000" b="0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. ITGAE was the top gene in the cluster and this cluster was </a:t>
            </a:r>
            <a:r>
              <a:rPr lang="en-US" sz="1000" b="0" i="0" u="none" strike="noStrike" cap="none" dirty="0" err="1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idenfied</a:t>
            </a:r>
            <a:r>
              <a:rPr lang="en-US" sz="1000" b="0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 as ITGAE+ cells</a:t>
            </a:r>
            <a:r>
              <a:rPr lang="en-GB" sz="1000" b="0" i="0" u="none" strike="noStrike" cap="none" dirty="0">
                <a:solidFill>
                  <a:schemeClr val="dk1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.</a:t>
            </a:r>
            <a:endParaRPr sz="1400" b="0" i="0" u="none" strike="noStrike" cap="none" dirty="0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sp>
        <p:nvSpPr>
          <p:cNvPr id="85" name="Google Shape;85;p1"/>
          <p:cNvSpPr txBox="1"/>
          <p:nvPr/>
        </p:nvSpPr>
        <p:spPr>
          <a:xfrm>
            <a:off x="6953250" y="7191375"/>
            <a:ext cx="9144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 panose="020B0604020202020204"/>
              <a:buNone/>
            </a:pPr>
            <a:endParaRPr sz="1400" b="0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pic>
        <p:nvPicPr>
          <p:cNvPr id="7" name="图片 6" descr="Rplot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8300" y="649605"/>
            <a:ext cx="3237865" cy="231267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87" name="Google Shape;87;p1"/>
          <p:cNvSpPr txBox="1"/>
          <p:nvPr/>
        </p:nvSpPr>
        <p:spPr>
          <a:xfrm>
            <a:off x="323850" y="579740"/>
            <a:ext cx="4287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</a:pPr>
            <a:r>
              <a:rPr lang="en-GB" sz="1000" b="1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rPr>
              <a:t>A</a:t>
            </a:r>
            <a:endParaRPr sz="1000" b="1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pic>
        <p:nvPicPr>
          <p:cNvPr id="8" name="图片 7" descr="Rplot1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79570" y="649605"/>
            <a:ext cx="3237865" cy="231267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82" name="Google Shape;82;p1"/>
          <p:cNvSpPr txBox="1"/>
          <p:nvPr/>
        </p:nvSpPr>
        <p:spPr>
          <a:xfrm>
            <a:off x="4128770" y="567040"/>
            <a:ext cx="4287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</a:pPr>
            <a:r>
              <a:rPr lang="en-GB" sz="1000" b="1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rPr>
              <a:t>B</a:t>
            </a:r>
            <a:endParaRPr sz="1000" b="1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pic>
        <p:nvPicPr>
          <p:cNvPr id="9" name="图片 8" descr="Rplot1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8300" y="3243580"/>
            <a:ext cx="3237865" cy="231267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83" name="Google Shape;83;p1"/>
          <p:cNvSpPr txBox="1"/>
          <p:nvPr/>
        </p:nvSpPr>
        <p:spPr>
          <a:xfrm>
            <a:off x="330200" y="3173420"/>
            <a:ext cx="4287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</a:pPr>
            <a:r>
              <a:rPr lang="en-GB" sz="1000" b="1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rPr>
              <a:t>C</a:t>
            </a:r>
            <a:endParaRPr sz="1000" b="1" i="0" u="none" strike="noStrike" cap="none">
              <a:solidFill>
                <a:srgbClr val="000000"/>
              </a:solidFill>
              <a:latin typeface="Arial" panose="020B0604020202020204"/>
              <a:ea typeface="Arial" panose="020B0604020202020204"/>
              <a:cs typeface="Arial" panose="020B0604020202020204"/>
              <a:sym typeface="Arial" panose="020B0604020202020204"/>
            </a:endParaRPr>
          </a:p>
        </p:txBody>
      </p:sp>
      <p:pic>
        <p:nvPicPr>
          <p:cNvPr id="10" name="图片 9" descr="Rplot1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79570" y="3243580"/>
            <a:ext cx="3237865" cy="231267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" name="Google Shape;83;p1"/>
          <p:cNvSpPr txBox="1"/>
          <p:nvPr>
            <p:custDataLst>
              <p:tags r:id="rId1"/>
            </p:custDataLst>
          </p:nvPr>
        </p:nvSpPr>
        <p:spPr>
          <a:xfrm>
            <a:off x="4135120" y="3160720"/>
            <a:ext cx="428700" cy="3352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 panose="020B0604020202020204"/>
              <a:buNone/>
            </a:pPr>
            <a:r>
              <a:rPr lang="en-US" altLang="en-GB" sz="1000" b="1" i="0" u="none" strike="noStrike" cap="none">
                <a:solidFill>
                  <a:srgbClr val="000000"/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Arial" panose="020B0604020202020204"/>
              </a:rPr>
              <a:t>D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1DF87FD-BC82-4F79-AF32-05BA61BF4229}"/>
              </a:ext>
            </a:extLst>
          </p:cNvPr>
          <p:cNvPicPr/>
          <p:nvPr/>
        </p:nvPicPr>
        <p:blipFill>
          <a:blip r:embed="rId2" r:link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2935" y="996896"/>
            <a:ext cx="4997235" cy="2941555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Google Shape;55;p1">
            <a:extLst>
              <a:ext uri="{FF2B5EF4-FFF2-40B4-BE49-F238E27FC236}">
                <a16:creationId xmlns:a16="http://schemas.microsoft.com/office/drawing/2014/main" id="{5E88AA63-429C-455B-8BED-D3E6D6A32B1D}"/>
              </a:ext>
            </a:extLst>
          </p:cNvPr>
          <p:cNvSpPr txBox="1"/>
          <p:nvPr/>
        </p:nvSpPr>
        <p:spPr>
          <a:xfrm>
            <a:off x="735965" y="0"/>
            <a:ext cx="6300470" cy="4889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000"/>
              <a:buFont typeface="Arial" panose="020B0604020202020204"/>
              <a:buNone/>
            </a:pPr>
            <a:r>
              <a:rPr lang="en-GB" sz="2000" b="1" i="0" u="none" strike="noStrike" cap="none" dirty="0">
                <a:solidFill>
                  <a:srgbClr val="000000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Figure </a:t>
            </a:r>
            <a:r>
              <a:rPr lang="en-US" altLang="en-GB" sz="2000" b="1" i="0" u="none" strike="noStrike" cap="none" dirty="0">
                <a:solidFill>
                  <a:srgbClr val="000000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S3</a:t>
            </a:r>
            <a:r>
              <a:rPr lang="en-GB" sz="2000" b="1" i="0" u="none" strike="noStrike" cap="none" dirty="0">
                <a:solidFill>
                  <a:srgbClr val="000000"/>
                </a:solidFill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: </a:t>
            </a:r>
            <a:r>
              <a:rPr lang="en-US" sz="2000" b="1" dirty="0">
                <a:latin typeface="Calibri" panose="020F0502020204030204"/>
                <a:ea typeface="Calibri" panose="020F0502020204030204"/>
                <a:cs typeface="Calibri" panose="020F0502020204030204"/>
                <a:sym typeface="Calibri" panose="020F0502020204030204"/>
              </a:rPr>
              <a:t>Percentage of mitochondrial DNA</a:t>
            </a:r>
            <a:endParaRPr lang="en-US" altLang="en-GB" sz="2000" b="1" i="0" u="none" strike="noStrike" cap="none" dirty="0">
              <a:solidFill>
                <a:srgbClr val="000000"/>
              </a:solidFill>
              <a:latin typeface="Calibri" panose="020F0502020204030204"/>
              <a:ea typeface="Calibri" panose="020F0502020204030204"/>
              <a:cs typeface="Calibri" panose="020F0502020204030204"/>
              <a:sym typeface="Calibri" panose="020F0502020204030204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2C033D1-7B6C-4388-A831-015B19FAF4A1}"/>
              </a:ext>
            </a:extLst>
          </p:cNvPr>
          <p:cNvSpPr txBox="1"/>
          <p:nvPr/>
        </p:nvSpPr>
        <p:spPr>
          <a:xfrm>
            <a:off x="501529" y="4292508"/>
            <a:ext cx="654004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mitochondrial DNA levels in the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jority of the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lusters after filtering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low 10%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69567633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b07db198-57e0-4f10-97c7-4de5097dd883"/>
  <p:tag name="COMMONDATA" val="eyJoZGlkIjoiZTEzMDI5YmI1N2EzNzZhYzRiNzRmMWU3ZWIxMDhkZDkifQ==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4</TotalTime>
  <Words>245</Words>
  <Application>Microsoft Office PowerPoint</Application>
  <PresentationFormat>Custom</PresentationFormat>
  <Paragraphs>14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Simple Light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iping Zhou</dc:creator>
  <cp:lastModifiedBy>Huiping Zhou</cp:lastModifiedBy>
  <cp:revision>6</cp:revision>
  <dcterms:created xsi:type="dcterms:W3CDTF">2023-06-26T02:47:00Z</dcterms:created>
  <dcterms:modified xsi:type="dcterms:W3CDTF">2024-02-01T07:05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96844C6ECEC42A3AE2BF7083323D606_13</vt:lpwstr>
  </property>
  <property fmtid="{D5CDD505-2E9C-101B-9397-08002B2CF9AE}" pid="3" name="KSOProductBuildVer">
    <vt:lpwstr>2052-11.1.0.14309</vt:lpwstr>
  </property>
</Properties>
</file>